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4"/>
  </p:sldMasterIdLst>
  <p:notesMasterIdLst>
    <p:notesMasterId r:id="rId12"/>
  </p:notesMasterIdLst>
  <p:sldIdLst>
    <p:sldId id="300" r:id="rId5"/>
    <p:sldId id="342" r:id="rId6"/>
    <p:sldId id="329" r:id="rId7"/>
    <p:sldId id="336" r:id="rId8"/>
    <p:sldId id="332" r:id="rId9"/>
    <p:sldId id="331" r:id="rId10"/>
    <p:sldId id="340" r:id="rId11"/>
  </p:sldIdLst>
  <p:sldSz cx="7772400" cy="10058400"/>
  <p:notesSz cx="6934200" cy="92202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" orient="horz" pos="2448" userDrawn="1">
          <p15:clr>
            <a:srgbClr val="A4A3A4"/>
          </p15:clr>
        </p15:guide>
        <p15:guide id="8" orient="horz" pos="5760" userDrawn="1">
          <p15:clr>
            <a:srgbClr val="A4A3A4"/>
          </p15:clr>
        </p15:guide>
        <p15:guide id="9" pos="456" userDrawn="1">
          <p15:clr>
            <a:srgbClr val="A4A3A4"/>
          </p15:clr>
        </p15:guide>
        <p15:guide id="10" pos="1176" userDrawn="1">
          <p15:clr>
            <a:srgbClr val="A4A3A4"/>
          </p15:clr>
        </p15:guide>
        <p15:guide id="11" pos="2376" userDrawn="1">
          <p15:clr>
            <a:srgbClr val="A4A3A4"/>
          </p15:clr>
        </p15:guide>
        <p15:guide id="12" pos="720" userDrawn="1">
          <p15:clr>
            <a:srgbClr val="A4A3A4"/>
          </p15:clr>
        </p15:guide>
        <p15:guide id="13" orient="horz" pos="4992" userDrawn="1">
          <p15:clr>
            <a:srgbClr val="A4A3A4"/>
          </p15:clr>
        </p15:guide>
        <p15:guide id="14" orient="horz" pos="2184" userDrawn="1">
          <p15:clr>
            <a:srgbClr val="A4A3A4"/>
          </p15:clr>
        </p15:guide>
        <p15:guide id="15" orient="horz" pos="3888" userDrawn="1">
          <p15:clr>
            <a:srgbClr val="A4A3A4"/>
          </p15:clr>
        </p15:guide>
        <p15:guide id="16" orient="horz" pos="5640" userDrawn="1">
          <p15:clr>
            <a:srgbClr val="A4A3A4"/>
          </p15:clr>
        </p15:guide>
        <p15:guide id="17" orient="horz" pos="1080" userDrawn="1">
          <p15:clr>
            <a:srgbClr val="A4A3A4"/>
          </p15:clr>
        </p15:guide>
        <p15:guide id="18" pos="24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AF2DF"/>
    <a:srgbClr val="FF5B5B"/>
    <a:srgbClr val="F88B2C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992" autoAdjust="0"/>
    <p:restoredTop sz="92714" autoAdjust="0"/>
  </p:normalViewPr>
  <p:slideViewPr>
    <p:cSldViewPr snapToGrid="0" showGuides="1">
      <p:cViewPr varScale="1">
        <p:scale>
          <a:sx n="61" d="100"/>
          <a:sy n="61" d="100"/>
        </p:scale>
        <p:origin x="2052" y="90"/>
      </p:cViewPr>
      <p:guideLst>
        <p:guide orient="horz" pos="2448"/>
        <p:guide orient="horz" pos="5760"/>
        <p:guide pos="456"/>
        <p:guide pos="1176"/>
        <p:guide pos="2376"/>
        <p:guide pos="720"/>
        <p:guide orient="horz" pos="4992"/>
        <p:guide orient="horz" pos="2184"/>
        <p:guide orient="horz" pos="3888"/>
        <p:guide orient="horz" pos="5640"/>
        <p:guide orient="horz" pos="1080"/>
        <p:guide pos="24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B19B111E-95C0-4C12-8AF1-86DEB4EC651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1"/>
            <a:ext cx="3004820" cy="462900"/>
          </a:xfrm>
          <a:prstGeom prst="rect">
            <a:avLst/>
          </a:prstGeom>
        </p:spPr>
        <p:txBody>
          <a:bodyPr vert="horz" lIns="90568" tIns="45284" rIns="90568" bIns="45284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F33051-1752-43EC-8140-3300BE92AD79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927776" y="1"/>
            <a:ext cx="3004820" cy="462900"/>
          </a:xfrm>
          <a:prstGeom prst="rect">
            <a:avLst/>
          </a:prstGeom>
        </p:spPr>
        <p:txBody>
          <a:bodyPr vert="horz" lIns="90568" tIns="45284" rIns="90568" bIns="45284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7A43B0E7-5D12-4F1C-BA89-BBC5DFD408F4}" type="datetimeFigureOut">
              <a:rPr lang="en-US"/>
              <a:pPr>
                <a:defRPr/>
              </a:pPr>
              <a:t>9/24/2020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CE9B3046-D5D6-41C8-9677-6D7A508A781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265363" y="1152525"/>
            <a:ext cx="2403475" cy="3113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568" tIns="45284" rIns="90568" bIns="45284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D6AFFE99-D98E-457D-94D8-365D754D85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93421" y="4436909"/>
            <a:ext cx="5547360" cy="3630769"/>
          </a:xfrm>
          <a:prstGeom prst="rect">
            <a:avLst/>
          </a:prstGeom>
        </p:spPr>
        <p:txBody>
          <a:bodyPr vert="horz" lIns="90568" tIns="45284" rIns="90568" bIns="45284" rtlCol="0"/>
          <a:lstStyle/>
          <a:p>
            <a:pPr lvl="0"/>
            <a:r>
              <a:rPr lang="en-US" noProof="0"/>
              <a:t>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CC4318-2DE9-4F34-BCDA-3F9C1D229DEC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757303"/>
            <a:ext cx="3004820" cy="462900"/>
          </a:xfrm>
          <a:prstGeom prst="rect">
            <a:avLst/>
          </a:prstGeom>
        </p:spPr>
        <p:txBody>
          <a:bodyPr vert="horz" lIns="90568" tIns="45284" rIns="90568" bIns="45284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F38631-B36E-4C36-B27B-CF1649A38FE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927776" y="8757303"/>
            <a:ext cx="3004820" cy="462900"/>
          </a:xfrm>
          <a:prstGeom prst="rect">
            <a:avLst/>
          </a:prstGeom>
        </p:spPr>
        <p:txBody>
          <a:bodyPr vert="horz" lIns="90568" tIns="45284" rIns="90568" bIns="45284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9DFB9C74-1AAF-4A0F-9161-6C640CE8F21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Slide Image Placeholder 1">
            <a:extLst>
              <a:ext uri="{FF2B5EF4-FFF2-40B4-BE49-F238E27FC236}">
                <a16:creationId xmlns:a16="http://schemas.microsoft.com/office/drawing/2014/main" id="{15A19FBE-0D4E-49D0-BB44-56BAB3B3FA18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4339" name="Notes Placeholder 2">
            <a:extLst>
              <a:ext uri="{FF2B5EF4-FFF2-40B4-BE49-F238E27FC236}">
                <a16:creationId xmlns:a16="http://schemas.microsoft.com/office/drawing/2014/main" id="{9743041D-BD95-4C92-8C77-7A6A43E79DC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t>NY-ESO transduced cells, lymphocytes, live, CD8</a:t>
            </a:r>
            <a:r>
              <a:rPr lang="en-US" altLang="en-US" baseline="30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t> gated</a:t>
            </a:r>
          </a:p>
          <a:p>
            <a:pPr eaLnBrk="1" hangingPunct="1">
              <a:spcBef>
                <a:spcPct val="0"/>
              </a:spcBef>
            </a:pPr>
            <a:r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t>6 hour coculture with plate-bound OKT3 (stim)</a:t>
            </a:r>
          </a:p>
          <a:p>
            <a:pPr eaLnBrk="1" hangingPunct="1">
              <a:spcBef>
                <a:spcPct val="0"/>
              </a:spcBef>
            </a:pPr>
            <a:r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t>Wes performed with 2e6 cells without resting and without stimulation</a:t>
            </a:r>
          </a:p>
          <a:p>
            <a:pPr eaLnBrk="1" hangingPunct="1">
              <a:spcBef>
                <a:spcPct val="0"/>
              </a:spcBef>
            </a:pPr>
            <a:endParaRPr lang="en-US" altLang="en-US"/>
          </a:p>
        </p:txBody>
      </p:sp>
      <p:sp>
        <p:nvSpPr>
          <p:cNvPr id="14340" name="Slide Number Placeholder 3">
            <a:extLst>
              <a:ext uri="{FF2B5EF4-FFF2-40B4-BE49-F238E27FC236}">
                <a16:creationId xmlns:a16="http://schemas.microsoft.com/office/drawing/2014/main" id="{A10FFBA8-88AD-42E9-93F5-7C53F9A591BA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35872" indent="-283028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32109" indent="-226422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584954" indent="-226422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37797" indent="-226422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490641" indent="-226422" defTabSz="452844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43485" indent="-226422" defTabSz="452844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396328" indent="-226422" defTabSz="452844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49172" indent="-226422" defTabSz="452844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2F01646D-33B7-4711-9BC8-408B0CAC4B7D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4-1BB upregulation of reactive TIL fragment (Pt. 4071) and antigen loaded autologous B cells after an overnight coculture. (</a:t>
            </a: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4-1BB upregulation in reactive CD8</a:t>
            </a:r>
            <a:r>
              <a:rPr lang="en-US" alt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US" alt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earing the clonotypic V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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7 TCR TIL. (</a:t>
            </a: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Composition of CD4</a:t>
            </a:r>
            <a:r>
              <a:rPr lang="en-US" alt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CD8</a:t>
            </a:r>
            <a:r>
              <a:rPr lang="en-US" alt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US" alt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 cells bearing the clonotypic V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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7 TCR in the treatment TIL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9DFB9C74-1AAF-4A0F-9161-6C640CE8F21E}" type="slidenum">
              <a:rPr lang="en-US" smtClean="0"/>
              <a:pPr>
                <a:defRPr/>
              </a:pPr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5898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3ACEBD-90FD-4975-B6A0-F38B97EF27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326FF5-5910-4BA8-87F6-7B5F68AEF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E56140-FCAD-4CEA-8C60-336E8E1B67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7B4E15-EB31-4FC9-BD9B-683188C4045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539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D44A4B-FB0C-4AEF-980C-4ED3499B6F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D88443-097B-4BFD-8681-4F3BE4868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BA8669-F108-4AA7-8697-4CAA7040D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C62233-758A-4031-98B8-02004BB2E09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183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CC0B33-CE2F-496E-B9D8-ABD6962D5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E34EC9-0110-49E5-AB5E-D6050BD0F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6A449B-C84B-42B8-9D99-A5A996F7C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5B12CF-D6BA-4A68-8568-A46DA404A8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77697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4">
            <a:extLst>
              <a:ext uri="{FF2B5EF4-FFF2-40B4-BE49-F238E27FC236}">
                <a16:creationId xmlns:a16="http://schemas.microsoft.com/office/drawing/2014/main" id="{05B10A62-EFC8-44E1-BAFD-22C8B1F70783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97FDAE-1DF9-40E3-A69C-3A5FC2B9406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739642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A25CC8-6545-4490-A9F2-0E39F3599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73808-E7E6-4C29-84B3-86D676105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A0E514-0317-4D75-9FDB-5291ED280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0E35E9-D2C7-4216-9E2B-FB5A45A099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467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83E4B4-F86B-41E6-9CCC-13DB0FDAA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4D21F7-3F6B-4AD3-8018-01170FFB9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9DB68B-7B2B-4B90-9A63-A75D6F27F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6773DD-12FA-43F2-A5EE-DBDF24C0613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449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0FB6545-21EE-4EC5-AC67-828774609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634C5CFF-AD5A-4F55-ABDD-26C819081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2E22A9EC-8246-49E6-8449-C523F584E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4B9810-3479-4D73-9CC2-01C2A6A749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531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DA6E9703-4B25-4911-9E04-2AC1AA144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8B8A6CE5-CE83-4460-AFD0-E452CEDA7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21C38029-CA2A-43C5-989A-736372B09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383D90-9233-415C-B689-2881AB3085F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102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A66B6BA4-BC9F-47DD-8063-657E3CBCD8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83652FAB-A627-434E-98EC-34D2353E4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ACA47AD4-61C9-4950-9044-C595BC1CDC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93038D-85F6-4FDB-9B85-AAFBCBAD81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616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A0750B91-A25D-4C5A-B419-9D784596B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3F830210-80A9-4237-A506-48DF568B5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03C89BAC-E722-45C1-B33A-DB29E3072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C1F333-6F43-4160-BAD1-155DE7AD796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746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AFF14E9-3D20-4043-9D8B-185FF6924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BF62303-BE67-46BB-A58A-85215B669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A9B0820-4DD1-4A35-B47B-235AD3659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F49E54-BDCA-45DD-8919-AEE5ED6916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071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rtlCol="0">
            <a:normAutofit/>
          </a:bodyPr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058070FF-FE85-47A3-B70B-30835D17B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8BB4E63-6CCA-4836-961F-B64DFB60D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741F5F83-3843-40E2-AEB0-AB5123B55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F2355C-C4E5-4151-83E8-695F36764FE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8914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467BA850-1434-4CD4-AE15-0CE0E62A2400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534988" y="534988"/>
            <a:ext cx="6702425" cy="1944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000B7D62-5036-437B-BEC5-7CBC59F2293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534988" y="2678113"/>
            <a:ext cx="6702425" cy="6381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71475-7EB2-4232-BB32-9EF5399BB2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34988" y="9323388"/>
            <a:ext cx="1747837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02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06EAEE-6635-4252-83F7-C546B40B25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574925" y="9323388"/>
            <a:ext cx="2622550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02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EFB573-598E-45CD-B5C3-783A594036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5489575" y="9323388"/>
            <a:ext cx="1747838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02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CBDEB0A3-422F-47F8-A944-1E2E316EC82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13" r:id="rId1"/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</p:sldLayoutIdLst>
  <p:hf sldNum="0" hdr="0" ftr="0" dt="0"/>
  <p:txStyles>
    <p:titleStyle>
      <a:lvl1pPr algn="l" defTabSz="776288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7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776288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2pPr>
      <a:lvl3pPr algn="l" defTabSz="776288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3pPr>
      <a:lvl4pPr algn="l" defTabSz="776288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4pPr>
      <a:lvl5pPr algn="l" defTabSz="776288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93675" indent="-193675" algn="l" defTabSz="776288" rtl="0" eaLnBrk="0" fontAlgn="base" hangingPunct="0">
        <a:lnSpc>
          <a:spcPct val="90000"/>
        </a:lnSpc>
        <a:spcBef>
          <a:spcPts val="850"/>
        </a:spcBef>
        <a:spcAft>
          <a:spcPct val="0"/>
        </a:spcAft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82613" indent="-193675" algn="l" defTabSz="776288" rtl="0" eaLnBrk="0" fontAlgn="base" hangingPunct="0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3675" algn="l" defTabSz="776288" rtl="0" eaLnBrk="0" fontAlgn="base" hangingPunct="0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58900" indent="-193675" algn="l" defTabSz="776288" rtl="0" eaLnBrk="0" fontAlgn="base" hangingPunct="0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47838" indent="-193675" algn="l" defTabSz="776288" rtl="0" eaLnBrk="0" fontAlgn="base" hangingPunct="0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image" Target="../media/image7.tif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0.emf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6.emf"/><Relationship Id="rId4" Type="http://schemas.openxmlformats.org/officeDocument/2006/relationships/image" Target="../media/image8.png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13.emf"/><Relationship Id="rId4" Type="http://schemas.openxmlformats.org/officeDocument/2006/relationships/oleObject" Target="../embeddings/oleObject6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1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CA5DAAC-D2DC-4D1D-AC56-40764D5AAFA9}"/>
              </a:ext>
            </a:extLst>
          </p:cNvPr>
          <p:cNvSpPr txBox="1"/>
          <p:nvPr/>
        </p:nvSpPr>
        <p:spPr>
          <a:xfrm>
            <a:off x="4722812" y="3545681"/>
            <a:ext cx="927100" cy="26161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ISH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095A2A1-49D8-4567-9607-28E11BA6FF3C}"/>
              </a:ext>
            </a:extLst>
          </p:cNvPr>
          <p:cNvSpPr txBox="1"/>
          <p:nvPr/>
        </p:nvSpPr>
        <p:spPr>
          <a:xfrm>
            <a:off x="4722812" y="3956844"/>
            <a:ext cx="1293813" cy="26161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ACTIN</a:t>
            </a:r>
          </a:p>
        </p:txBody>
      </p:sp>
      <p:pic>
        <p:nvPicPr>
          <p:cNvPr id="13316" name="Picture 7">
            <a:extLst>
              <a:ext uri="{FF2B5EF4-FFF2-40B4-BE49-F238E27FC236}">
                <a16:creationId xmlns:a16="http://schemas.microsoft.com/office/drawing/2014/main" id="{861973A1-4FA9-4E51-ABC1-D84B5BB70D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3" t="54523" r="54704" b="35252"/>
          <a:stretch>
            <a:fillRect/>
          </a:stretch>
        </p:blipFill>
        <p:spPr bwMode="auto">
          <a:xfrm>
            <a:off x="2517775" y="3542506"/>
            <a:ext cx="2174875" cy="388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17" name="Picture 8">
            <a:extLst>
              <a:ext uri="{FF2B5EF4-FFF2-40B4-BE49-F238E27FC236}">
                <a16:creationId xmlns:a16="http://schemas.microsoft.com/office/drawing/2014/main" id="{2E60ECD1-2AAF-42FB-B5E1-2D1F3598E8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6" t="52037" r="54259" b="38364"/>
          <a:stretch>
            <a:fillRect/>
          </a:stretch>
        </p:blipFill>
        <p:spPr bwMode="auto">
          <a:xfrm>
            <a:off x="2405062" y="4001294"/>
            <a:ext cx="230346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13318" name="Object 9">
            <a:extLst>
              <a:ext uri="{FF2B5EF4-FFF2-40B4-BE49-F238E27FC236}">
                <a16:creationId xmlns:a16="http://schemas.microsoft.com/office/drawing/2014/main" id="{D1C0D66B-54D1-46BF-826B-136753DBCB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85232"/>
              </p:ext>
            </p:extLst>
          </p:nvPr>
        </p:nvGraphicFramePr>
        <p:xfrm>
          <a:off x="2617214" y="4873948"/>
          <a:ext cx="2783618" cy="23483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3" name="Prism 7" r:id="rId6" imgW="3788628" imgH="3194698" progId="Prism7.Document">
                  <p:embed/>
                </p:oleObj>
              </mc:Choice>
              <mc:Fallback>
                <p:oleObj name="Prism 7" r:id="rId6" imgW="3788628" imgH="3194698" progId="Prism7.Document">
                  <p:embed/>
                  <p:pic>
                    <p:nvPicPr>
                      <p:cNvPr id="13318" name="Object 9">
                        <a:extLst>
                          <a:ext uri="{FF2B5EF4-FFF2-40B4-BE49-F238E27FC236}">
                            <a16:creationId xmlns:a16="http://schemas.microsoft.com/office/drawing/2014/main" id="{D1C0D66B-54D1-46BF-826B-136753DBCB4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17214" y="4873948"/>
                        <a:ext cx="2783618" cy="234838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7">
            <a:extLst>
              <a:ext uri="{FF2B5EF4-FFF2-40B4-BE49-F238E27FC236}">
                <a16:creationId xmlns:a16="http://schemas.microsoft.com/office/drawing/2014/main" id="{03D44A2B-4D6B-4053-9387-3DDF4B65AE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60590" y="265763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321" name="TextBox 1">
            <a:extLst>
              <a:ext uri="{FF2B5EF4-FFF2-40B4-BE49-F238E27FC236}">
                <a16:creationId xmlns:a16="http://schemas.microsoft.com/office/drawing/2014/main" id="{4F264FD5-958B-4149-813A-AC989A36B8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150" y="438150"/>
            <a:ext cx="235032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tended Data Figur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A02C52A-870F-463A-9A05-BA550ECF1BDD}"/>
              </a:ext>
            </a:extLst>
          </p:cNvPr>
          <p:cNvSpPr txBox="1"/>
          <p:nvPr/>
        </p:nvSpPr>
        <p:spPr>
          <a:xfrm rot="16200000">
            <a:off x="2393950" y="3018165"/>
            <a:ext cx="927100" cy="26161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Untx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9A381AD-B09C-419F-8D99-7027AF4552FA}"/>
              </a:ext>
            </a:extLst>
          </p:cNvPr>
          <p:cNvSpPr txBox="1"/>
          <p:nvPr/>
        </p:nvSpPr>
        <p:spPr>
          <a:xfrm rot="16200000">
            <a:off x="2714532" y="3018165"/>
            <a:ext cx="927100" cy="26161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F8B0A82-F8F9-4DBB-854F-09D15132DF00}"/>
              </a:ext>
            </a:extLst>
          </p:cNvPr>
          <p:cNvSpPr txBox="1"/>
          <p:nvPr/>
        </p:nvSpPr>
        <p:spPr>
          <a:xfrm rot="16200000">
            <a:off x="3035114" y="3018165"/>
            <a:ext cx="927100" cy="26161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uide 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6A5E9D5-12A0-4FFB-B4C3-E9569A2E50DB}"/>
              </a:ext>
            </a:extLst>
          </p:cNvPr>
          <p:cNvSpPr txBox="1"/>
          <p:nvPr/>
        </p:nvSpPr>
        <p:spPr>
          <a:xfrm rot="16200000">
            <a:off x="3355696" y="3018165"/>
            <a:ext cx="927100" cy="26161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uide 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9FF22E0-08D5-4077-B307-94A944186E95}"/>
              </a:ext>
            </a:extLst>
          </p:cNvPr>
          <p:cNvSpPr txBox="1"/>
          <p:nvPr/>
        </p:nvSpPr>
        <p:spPr>
          <a:xfrm rot="16200000">
            <a:off x="3676278" y="3018165"/>
            <a:ext cx="927100" cy="26161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uide 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4AAA6BD-5E59-4736-9C0C-C71EF36AFC00}"/>
              </a:ext>
            </a:extLst>
          </p:cNvPr>
          <p:cNvSpPr txBox="1"/>
          <p:nvPr/>
        </p:nvSpPr>
        <p:spPr>
          <a:xfrm rot="16200000">
            <a:off x="3996859" y="3018164"/>
            <a:ext cx="927100" cy="26161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uide 4</a:t>
            </a:r>
          </a:p>
        </p:txBody>
      </p:sp>
      <p:sp>
        <p:nvSpPr>
          <p:cNvPr id="18" name="TextBox 7">
            <a:extLst>
              <a:ext uri="{FF2B5EF4-FFF2-40B4-BE49-F238E27FC236}">
                <a16:creationId xmlns:a16="http://schemas.microsoft.com/office/drawing/2014/main" id="{A7FBB865-F8C2-4E0F-A9CA-49333B019E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69075" y="4752201"/>
            <a:ext cx="27924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" name="Picture 161" descr="A screenshot of a cell phone&#10;&#10;Description automatically generated">
            <a:extLst>
              <a:ext uri="{FF2B5EF4-FFF2-40B4-BE49-F238E27FC236}">
                <a16:creationId xmlns:a16="http://schemas.microsoft.com/office/drawing/2014/main" id="{6A7B7704-1DC0-4249-89EB-9123493B89B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81" t="2405" b="79131"/>
          <a:stretch/>
        </p:blipFill>
        <p:spPr>
          <a:xfrm>
            <a:off x="3351220" y="5047973"/>
            <a:ext cx="2861443" cy="1435805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6AC5DDA6-8E46-4DB6-B515-9D6599E130F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6017" y="1705477"/>
            <a:ext cx="4077954" cy="13230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101">
            <a:extLst>
              <a:ext uri="{FF2B5EF4-FFF2-40B4-BE49-F238E27FC236}">
                <a16:creationId xmlns:a16="http://schemas.microsoft.com/office/drawing/2014/main" id="{BCDBCF89-9154-40EA-B142-BDBF639E62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9681" y="507041"/>
            <a:ext cx="23535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tended Data Figure 2</a:t>
            </a:r>
          </a:p>
        </p:txBody>
      </p:sp>
      <p:sp>
        <p:nvSpPr>
          <p:cNvPr id="4" name="TextBox 43">
            <a:extLst>
              <a:ext uri="{FF2B5EF4-FFF2-40B4-BE49-F238E27FC236}">
                <a16:creationId xmlns:a16="http://schemas.microsoft.com/office/drawing/2014/main" id="{C21B8EAD-965F-4575-9EF0-A12CD87B03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66745" y="4844860"/>
            <a:ext cx="384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A829B9D-B6C9-4027-A6C8-B28AD758086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889481" y="6649670"/>
          <a:ext cx="2144127" cy="19362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3" name="Prism 7" r:id="rId5" imgW="3164873" imgH="3180520" progId="Prism7.Document">
                  <p:embed/>
                </p:oleObj>
              </mc:Choice>
              <mc:Fallback>
                <p:oleObj name="Prism 7" r:id="rId5" imgW="3164873" imgH="3180520" progId="Prism7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A829B9D-B6C9-4027-A6C8-B28AD75808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89481" y="6649670"/>
                        <a:ext cx="2144127" cy="19362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03752FC-CCDB-4452-BFC5-279FACC7ADA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65172" y="6662755"/>
          <a:ext cx="2652959" cy="19091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4" name="Prism 7" r:id="rId7" imgW="4072055" imgH="3175838" progId="Prism7.Document">
                  <p:embed/>
                </p:oleObj>
              </mc:Choice>
              <mc:Fallback>
                <p:oleObj name="Prism 7" r:id="rId7" imgW="4072055" imgH="3175838" progId="Prism7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003752FC-CCDB-4452-BFC5-279FACC7AD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65172" y="6662755"/>
                        <a:ext cx="2652959" cy="19091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43">
            <a:extLst>
              <a:ext uri="{FF2B5EF4-FFF2-40B4-BE49-F238E27FC236}">
                <a16:creationId xmlns:a16="http://schemas.microsoft.com/office/drawing/2014/main" id="{11333CB7-3B10-4316-922B-FC8EEE057E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1345" y="6743170"/>
            <a:ext cx="6901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th IL2</a:t>
            </a:r>
          </a:p>
        </p:txBody>
      </p:sp>
      <p:sp>
        <p:nvSpPr>
          <p:cNvPr id="8" name="TextBox 43">
            <a:extLst>
              <a:ext uri="{FF2B5EF4-FFF2-40B4-BE49-F238E27FC236}">
                <a16:creationId xmlns:a16="http://schemas.microsoft.com/office/drawing/2014/main" id="{C1CEA118-C97F-415F-A621-412332A69E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5754" y="6743170"/>
            <a:ext cx="6901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 IL2</a:t>
            </a:r>
          </a:p>
        </p:txBody>
      </p:sp>
      <p:sp>
        <p:nvSpPr>
          <p:cNvPr id="151" name="TextBox 43">
            <a:extLst>
              <a:ext uri="{FF2B5EF4-FFF2-40B4-BE49-F238E27FC236}">
                <a16:creationId xmlns:a16="http://schemas.microsoft.com/office/drawing/2014/main" id="{FE255060-121A-48F8-BD5C-CE14A1D82D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7874" y="2956953"/>
            <a:ext cx="384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2" name="TextBox 43">
            <a:extLst>
              <a:ext uri="{FF2B5EF4-FFF2-40B4-BE49-F238E27FC236}">
                <a16:creationId xmlns:a16="http://schemas.microsoft.com/office/drawing/2014/main" id="{A2F7100D-E4B8-4ED0-88A3-607E00FF4F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3915" y="2916616"/>
            <a:ext cx="384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3" name="TextBox 43">
            <a:extLst>
              <a:ext uri="{FF2B5EF4-FFF2-40B4-BE49-F238E27FC236}">
                <a16:creationId xmlns:a16="http://schemas.microsoft.com/office/drawing/2014/main" id="{5CB1CECF-9597-4B23-BF8D-1E6C26946C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0675" y="4894755"/>
            <a:ext cx="384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4" name="TextBox 43">
            <a:extLst>
              <a:ext uri="{FF2B5EF4-FFF2-40B4-BE49-F238E27FC236}">
                <a16:creationId xmlns:a16="http://schemas.microsoft.com/office/drawing/2014/main" id="{7193B50F-C2A2-43CB-87B1-0047E890DC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3196" y="1713521"/>
            <a:ext cx="384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155" name="Object 154">
            <a:extLst>
              <a:ext uri="{FF2B5EF4-FFF2-40B4-BE49-F238E27FC236}">
                <a16:creationId xmlns:a16="http://schemas.microsoft.com/office/drawing/2014/main" id="{3996B920-7458-4C13-8B94-B8413CD12BE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851149" y="3063128"/>
          <a:ext cx="1081087" cy="1722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5" name="Prism 7" r:id="rId9" imgW="2163335" imgH="3442712" progId="Prism7.Document">
                  <p:embed/>
                </p:oleObj>
              </mc:Choice>
              <mc:Fallback>
                <p:oleObj name="Prism 7" r:id="rId9" imgW="2163335" imgH="3442712" progId="Prism7.Document">
                  <p:embed/>
                  <p:pic>
                    <p:nvPicPr>
                      <p:cNvPr id="155" name="Object 154">
                        <a:extLst>
                          <a:ext uri="{FF2B5EF4-FFF2-40B4-BE49-F238E27FC236}">
                            <a16:creationId xmlns:a16="http://schemas.microsoft.com/office/drawing/2014/main" id="{3996B920-7458-4C13-8B94-B8413CD12B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851149" y="3063128"/>
                        <a:ext cx="1081087" cy="1722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9" name="Group 8">
            <a:extLst>
              <a:ext uri="{FF2B5EF4-FFF2-40B4-BE49-F238E27FC236}">
                <a16:creationId xmlns:a16="http://schemas.microsoft.com/office/drawing/2014/main" id="{72E5533A-0CD6-C04B-BDA0-56B8E0CD55E1}"/>
              </a:ext>
            </a:extLst>
          </p:cNvPr>
          <p:cNvGrpSpPr/>
          <p:nvPr/>
        </p:nvGrpSpPr>
        <p:grpSpPr>
          <a:xfrm>
            <a:off x="3219032" y="2938827"/>
            <a:ext cx="3518629" cy="1507412"/>
            <a:chOff x="3033083" y="3120534"/>
            <a:chExt cx="3518629" cy="1507412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1E30B990-1592-484D-8202-F0997B7DE5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10508" r="16473" b="67630"/>
            <a:stretch/>
          </p:blipFill>
          <p:spPr>
            <a:xfrm>
              <a:off x="3040981" y="3843285"/>
              <a:ext cx="2861443" cy="348638"/>
            </a:xfrm>
            <a:prstGeom prst="rect">
              <a:avLst/>
            </a:prstGeom>
          </p:spPr>
        </p:pic>
        <p:sp>
          <p:nvSpPr>
            <p:cNvPr id="19555" name="TextBox 19554">
              <a:extLst>
                <a:ext uri="{FF2B5EF4-FFF2-40B4-BE49-F238E27FC236}">
                  <a16:creationId xmlns:a16="http://schemas.microsoft.com/office/drawing/2014/main" id="{C75249BA-EECE-4C1A-A34F-E9D7BF8B38E9}"/>
                </a:ext>
              </a:extLst>
            </p:cNvPr>
            <p:cNvSpPr txBox="1"/>
            <p:nvPr/>
          </p:nvSpPr>
          <p:spPr>
            <a:xfrm>
              <a:off x="3679223" y="3120534"/>
              <a:ext cx="46038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50" u="sng" dirty="0">
                  <a:latin typeface="Arial" panose="020B0604020202020204" pitchFamily="34" charset="0"/>
                  <a:cs typeface="Arial" panose="020B0604020202020204" pitchFamily="34" charset="0"/>
                </a:rPr>
                <a:t>Pt. 1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45D8E611-74EA-45A0-87B1-DF671896D6D4}"/>
                </a:ext>
              </a:extLst>
            </p:cNvPr>
            <p:cNvSpPr txBox="1"/>
            <p:nvPr/>
          </p:nvSpPr>
          <p:spPr>
            <a:xfrm>
              <a:off x="4446687" y="3120534"/>
              <a:ext cx="46038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50" u="sng" dirty="0">
                  <a:latin typeface="Arial" panose="020B0604020202020204" pitchFamily="34" charset="0"/>
                  <a:cs typeface="Arial" panose="020B0604020202020204" pitchFamily="34" charset="0"/>
                </a:rPr>
                <a:t>Pt. 2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B6643B71-12C2-4C60-B667-14815239AA11}"/>
                </a:ext>
              </a:extLst>
            </p:cNvPr>
            <p:cNvSpPr txBox="1"/>
            <p:nvPr/>
          </p:nvSpPr>
          <p:spPr>
            <a:xfrm>
              <a:off x="5226051" y="3120534"/>
              <a:ext cx="46038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050" u="sng" dirty="0">
                  <a:latin typeface="Arial" panose="020B0604020202020204" pitchFamily="34" charset="0"/>
                  <a:cs typeface="Arial" panose="020B0604020202020204" pitchFamily="34" charset="0"/>
                </a:rPr>
                <a:t>Pt. 3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55C3075A-E51D-4424-85A1-0A1240F7E4BF}"/>
                </a:ext>
              </a:extLst>
            </p:cNvPr>
            <p:cNvSpPr txBox="1"/>
            <p:nvPr/>
          </p:nvSpPr>
          <p:spPr>
            <a:xfrm rot="16200000">
              <a:off x="3419748" y="3493067"/>
              <a:ext cx="6096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DA2CAF4A-1194-42A8-80F5-B90EE3AAE941}"/>
                </a:ext>
              </a:extLst>
            </p:cNvPr>
            <p:cNvSpPr txBox="1"/>
            <p:nvPr/>
          </p:nvSpPr>
          <p:spPr>
            <a:xfrm rot="16200000">
              <a:off x="3825983" y="3529799"/>
              <a:ext cx="53613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ISH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880B7187-74D6-4AFA-A27D-D48BB8297124}"/>
                </a:ext>
              </a:extLst>
            </p:cNvPr>
            <p:cNvSpPr txBox="1"/>
            <p:nvPr/>
          </p:nvSpPr>
          <p:spPr>
            <a:xfrm>
              <a:off x="5902424" y="3898021"/>
              <a:ext cx="649288" cy="261938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CISH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3D2A9081-8C88-4C0C-9C71-865EDFE21243}"/>
                </a:ext>
              </a:extLst>
            </p:cNvPr>
            <p:cNvSpPr txBox="1"/>
            <p:nvPr/>
          </p:nvSpPr>
          <p:spPr>
            <a:xfrm>
              <a:off x="5894526" y="4302892"/>
              <a:ext cx="635000" cy="261937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l-GR" sz="105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92CF0A35-F683-4229-A886-846670512116}"/>
                </a:ext>
              </a:extLst>
            </p:cNvPr>
            <p:cNvSpPr txBox="1"/>
            <p:nvPr/>
          </p:nvSpPr>
          <p:spPr>
            <a:xfrm rot="16200000">
              <a:off x="4201894" y="3493067"/>
              <a:ext cx="6096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40FB5D22-3810-4970-9FD2-9B6DB63BACD9}"/>
                </a:ext>
              </a:extLst>
            </p:cNvPr>
            <p:cNvSpPr txBox="1"/>
            <p:nvPr/>
          </p:nvSpPr>
          <p:spPr>
            <a:xfrm rot="16200000">
              <a:off x="4608131" y="3529800"/>
              <a:ext cx="53613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ISH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0F57C4E1-741D-4027-9A4A-889E6CCFCF61}"/>
                </a:ext>
              </a:extLst>
            </p:cNvPr>
            <p:cNvSpPr txBox="1"/>
            <p:nvPr/>
          </p:nvSpPr>
          <p:spPr>
            <a:xfrm rot="16200000">
              <a:off x="4957581" y="3493067"/>
              <a:ext cx="60960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167F4AD4-A924-4488-A5F9-705EF42D1A30}"/>
                </a:ext>
              </a:extLst>
            </p:cNvPr>
            <p:cNvSpPr txBox="1"/>
            <p:nvPr/>
          </p:nvSpPr>
          <p:spPr>
            <a:xfrm rot="16200000">
              <a:off x="5357856" y="3523838"/>
              <a:ext cx="54805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ISH</a:t>
              </a:r>
            </a:p>
          </p:txBody>
        </p:sp>
        <p:pic>
          <p:nvPicPr>
            <p:cNvPr id="158" name="Picture 157">
              <a:extLst>
                <a:ext uri="{FF2B5EF4-FFF2-40B4-BE49-F238E27FC236}">
                  <a16:creationId xmlns:a16="http://schemas.microsoft.com/office/drawing/2014/main" id="{D10430CB-6A70-4FC4-AC14-ACB9F9019A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32281" r="16473" b="47068"/>
            <a:stretch/>
          </p:blipFill>
          <p:spPr>
            <a:xfrm>
              <a:off x="3033083" y="4298605"/>
              <a:ext cx="2861443" cy="329341"/>
            </a:xfrm>
            <a:prstGeom prst="rect">
              <a:avLst/>
            </a:prstGeom>
          </p:spPr>
        </p:pic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5A90784F-F45B-4AF0-BE9E-EAB788233C38}"/>
                </a:ext>
              </a:extLst>
            </p:cNvPr>
            <p:cNvSpPr txBox="1"/>
            <p:nvPr/>
          </p:nvSpPr>
          <p:spPr>
            <a:xfrm>
              <a:off x="3920848" y="4120249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8.3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48186B4C-2D71-4219-A819-F81A5FF44EFB}"/>
                </a:ext>
              </a:extLst>
            </p:cNvPr>
            <p:cNvSpPr txBox="1"/>
            <p:nvPr/>
          </p:nvSpPr>
          <p:spPr>
            <a:xfrm>
              <a:off x="4695315" y="4120249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5.2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EF7BE6BE-4ECA-40DF-BC8D-41655A29DC66}"/>
                </a:ext>
              </a:extLst>
            </p:cNvPr>
            <p:cNvSpPr txBox="1"/>
            <p:nvPr/>
          </p:nvSpPr>
          <p:spPr>
            <a:xfrm>
              <a:off x="5472527" y="4120249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6.2</a:t>
              </a:r>
            </a:p>
          </p:txBody>
        </p:sp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C6598BE2-D3CE-C449-A20C-D291F2A3666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922139" y="4933618"/>
            <a:ext cx="1081087" cy="1625757"/>
          </a:xfrm>
          <a:prstGeom prst="rect">
            <a:avLst/>
          </a:prstGeom>
        </p:spPr>
      </p:pic>
      <p:sp>
        <p:nvSpPr>
          <p:cNvPr id="33" name="TextBox 43">
            <a:extLst>
              <a:ext uri="{FF2B5EF4-FFF2-40B4-BE49-F238E27FC236}">
                <a16:creationId xmlns:a16="http://schemas.microsoft.com/office/drawing/2014/main" id="{FC395D44-78EE-4718-A1F3-B992C3F8D4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51149" y="6529755"/>
            <a:ext cx="384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4" name="TextBox 43">
            <a:extLst>
              <a:ext uri="{FF2B5EF4-FFF2-40B4-BE49-F238E27FC236}">
                <a16:creationId xmlns:a16="http://schemas.microsoft.com/office/drawing/2014/main" id="{66EABFE3-0261-4734-97B4-9E5C597F0E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6840" y="6533457"/>
            <a:ext cx="384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4244506392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>
            <a:alpha val="0"/>
          </a:srgb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">
            <a:extLst>
              <a:ext uri="{FF2B5EF4-FFF2-40B4-BE49-F238E27FC236}">
                <a16:creationId xmlns:a16="http://schemas.microsoft.com/office/drawing/2014/main" id="{A4693496-0289-4720-9799-F9D2A03A64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410" y="102870"/>
            <a:ext cx="225491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tended Data Table 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EDEC9DD-3A1A-44BF-A27E-F07C9928B0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041" y="1142078"/>
            <a:ext cx="6316093" cy="5765735"/>
          </a:xfrm>
          <a:prstGeom prst="rect">
            <a:avLst/>
          </a:prstGeom>
          <a:solidFill>
            <a:schemeClr val="bg1"/>
          </a:solidFill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>
            <a:alpha val="0"/>
          </a:srgb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AE2F71F-FA4A-44BA-A6EF-277CE70D5A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8079774"/>
              </p:ext>
            </p:extLst>
          </p:nvPr>
        </p:nvGraphicFramePr>
        <p:xfrm>
          <a:off x="793750" y="3327227"/>
          <a:ext cx="5749925" cy="24967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1" name="Prism 7" r:id="rId3" imgW="7711226" imgH="3347992" progId="Prism7.Document">
                  <p:embed/>
                </p:oleObj>
              </mc:Choice>
              <mc:Fallback>
                <p:oleObj name="Prism 7" r:id="rId3" imgW="7711226" imgH="3347992" progId="Prism7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AE2F71F-FA4A-44BA-A6EF-277CE70D5A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93750" y="3327227"/>
                        <a:ext cx="5749925" cy="24967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1">
            <a:extLst>
              <a:ext uri="{FF2B5EF4-FFF2-40B4-BE49-F238E27FC236}">
                <a16:creationId xmlns:a16="http://schemas.microsoft.com/office/drawing/2014/main" id="{73D78E1D-A333-4E0B-8712-BE6A5ED3B1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150" y="438150"/>
            <a:ext cx="235032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tended Data Figure 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371EF5D-4947-41D5-8967-12F35F90A2FC}"/>
              </a:ext>
            </a:extLst>
          </p:cNvPr>
          <p:cNvSpPr txBox="1"/>
          <p:nvPr/>
        </p:nvSpPr>
        <p:spPr>
          <a:xfrm>
            <a:off x="5191125" y="3257419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&gt;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54D0EB-20E3-4F50-B71A-72C6B56A829C}"/>
              </a:ext>
            </a:extLst>
          </p:cNvPr>
          <p:cNvSpPr txBox="1"/>
          <p:nvPr/>
        </p:nvSpPr>
        <p:spPr>
          <a:xfrm>
            <a:off x="5105400" y="3257419"/>
            <a:ext cx="2632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&gt;</a:t>
            </a:r>
          </a:p>
        </p:txBody>
      </p:sp>
    </p:spTree>
    <p:extLst>
      <p:ext uri="{BB962C8B-B14F-4D97-AF65-F5344CB8AC3E}">
        <p14:creationId xmlns:p14="http://schemas.microsoft.com/office/powerpoint/2010/main" val="18127299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1">
            <a:extLst>
              <a:ext uri="{FF2B5EF4-FFF2-40B4-BE49-F238E27FC236}">
                <a16:creationId xmlns:a16="http://schemas.microsoft.com/office/drawing/2014/main" id="{38670CE8-62F1-4510-93F2-80316AE702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9569158"/>
              </p:ext>
            </p:extLst>
          </p:nvPr>
        </p:nvGraphicFramePr>
        <p:xfrm>
          <a:off x="1980236" y="3115575"/>
          <a:ext cx="3571875" cy="2084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5" name="Prism 7" r:id="rId4" imgW="4297860" imgH="2509553" progId="Prism7.Document">
                  <p:embed/>
                </p:oleObj>
              </mc:Choice>
              <mc:Fallback>
                <p:oleObj name="Prism 7" r:id="rId4" imgW="4297860" imgH="2509553" progId="Prism7.Document">
                  <p:embed/>
                  <p:pic>
                    <p:nvPicPr>
                      <p:cNvPr id="9" name="Object 1">
                        <a:extLst>
                          <a:ext uri="{FF2B5EF4-FFF2-40B4-BE49-F238E27FC236}">
                            <a16:creationId xmlns:a16="http://schemas.microsoft.com/office/drawing/2014/main" id="{38670CE8-62F1-4510-93F2-80316AE70285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80236" y="3115575"/>
                        <a:ext cx="3571875" cy="20843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89673C8-D207-4ABB-A705-7C01384213D3}"/>
              </a:ext>
            </a:extLst>
          </p:cNvPr>
          <p:cNvSpPr txBox="1"/>
          <p:nvPr/>
        </p:nvSpPr>
        <p:spPr>
          <a:xfrm>
            <a:off x="2039296" y="2977076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AECC632-1D76-4A61-9AF4-732EDE07F335}"/>
              </a:ext>
            </a:extLst>
          </p:cNvPr>
          <p:cNvSpPr txBox="1"/>
          <p:nvPr/>
        </p:nvSpPr>
        <p:spPr>
          <a:xfrm>
            <a:off x="3655812" y="2977076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8" name="TextBox 1">
            <a:extLst>
              <a:ext uri="{FF2B5EF4-FFF2-40B4-BE49-F238E27FC236}">
                <a16:creationId xmlns:a16="http://schemas.microsoft.com/office/drawing/2014/main" id="{AEC13D7E-6F67-4350-9F6E-0346A07266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547" y="485446"/>
            <a:ext cx="235032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tended Data Figure 4</a:t>
            </a:r>
          </a:p>
        </p:txBody>
      </p:sp>
    </p:spTree>
    <p:extLst>
      <p:ext uri="{BB962C8B-B14F-4D97-AF65-F5344CB8AC3E}">
        <p14:creationId xmlns:p14="http://schemas.microsoft.com/office/powerpoint/2010/main" val="6002159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5">
            <a:extLst>
              <a:ext uri="{FF2B5EF4-FFF2-40B4-BE49-F238E27FC236}">
                <a16:creationId xmlns:a16="http://schemas.microsoft.com/office/drawing/2014/main" id="{D14BF80F-6ADC-4DF7-B451-4F59D175008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340"/>
          <a:stretch>
            <a:fillRect/>
          </a:stretch>
        </p:blipFill>
        <p:spPr bwMode="auto">
          <a:xfrm>
            <a:off x="1880391" y="1679902"/>
            <a:ext cx="3546778" cy="3101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Content Placeholder 5">
            <a:extLst>
              <a:ext uri="{FF2B5EF4-FFF2-40B4-BE49-F238E27FC236}">
                <a16:creationId xmlns:a16="http://schemas.microsoft.com/office/drawing/2014/main" id="{E7A56AB3-F807-470D-9A74-0AA561D639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700" t="43167" b="46133"/>
          <a:stretch>
            <a:fillRect/>
          </a:stretch>
        </p:blipFill>
        <p:spPr bwMode="auto">
          <a:xfrm>
            <a:off x="5397929" y="2758545"/>
            <a:ext cx="649287" cy="269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10">
            <a:extLst>
              <a:ext uri="{FF2B5EF4-FFF2-40B4-BE49-F238E27FC236}">
                <a16:creationId xmlns:a16="http://schemas.microsoft.com/office/drawing/2014/main" id="{93754B65-43C1-4618-BA62-8488D68D82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0491" y="2776007"/>
            <a:ext cx="582613" cy="12223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n-reactive</a:t>
            </a:r>
          </a:p>
        </p:txBody>
      </p:sp>
      <p:sp>
        <p:nvSpPr>
          <p:cNvPr id="5" name="TextBox 88">
            <a:extLst>
              <a:ext uri="{FF2B5EF4-FFF2-40B4-BE49-F238E27FC236}">
                <a16:creationId xmlns:a16="http://schemas.microsoft.com/office/drawing/2014/main" id="{3AECDFAF-C796-4F10-B7E3-805AC37055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77316" y="2890307"/>
            <a:ext cx="400050" cy="1238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800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</a:p>
        </p:txBody>
      </p:sp>
      <p:sp>
        <p:nvSpPr>
          <p:cNvPr id="6" name="TextBox 93">
            <a:extLst>
              <a:ext uri="{FF2B5EF4-FFF2-40B4-BE49-F238E27FC236}">
                <a16:creationId xmlns:a16="http://schemas.microsoft.com/office/drawing/2014/main" id="{DA76ED10-2DBE-468F-B2AA-30F59E83E1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76653" y="1892042"/>
            <a:ext cx="2697854" cy="184666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NA-SEQ resections with P53 hotspots</a:t>
            </a:r>
          </a:p>
        </p:txBody>
      </p:sp>
      <p:sp>
        <p:nvSpPr>
          <p:cNvPr id="8" name="TextBox 1">
            <a:extLst>
              <a:ext uri="{FF2B5EF4-FFF2-40B4-BE49-F238E27FC236}">
                <a16:creationId xmlns:a16="http://schemas.microsoft.com/office/drawing/2014/main" id="{2D7C379A-B207-4F18-AED8-D057045BED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3819" y="533611"/>
            <a:ext cx="235032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tended Data Figure 5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18BA75DA-AB56-451A-A912-FF5E2BC275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06427" y="4954567"/>
            <a:ext cx="1428750" cy="142875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762562B-BDD9-454B-AC56-7EB7642ED8F8}"/>
              </a:ext>
            </a:extLst>
          </p:cNvPr>
          <p:cNvSpPr txBox="1"/>
          <p:nvPr/>
        </p:nvSpPr>
        <p:spPr>
          <a:xfrm>
            <a:off x="1763101" y="167990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2D7E2E1-6DB0-4A41-8947-F3342A0C3D6B}"/>
              </a:ext>
            </a:extLst>
          </p:cNvPr>
          <p:cNvSpPr txBox="1"/>
          <p:nvPr/>
        </p:nvSpPr>
        <p:spPr>
          <a:xfrm>
            <a:off x="1763101" y="4781877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F610148-8871-4412-85DB-C129FE7C12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11618" y="6491891"/>
            <a:ext cx="1408349" cy="140834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3039336-59C0-4154-A39B-50EE5B3C83C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15599" y="4954567"/>
            <a:ext cx="1428750" cy="142875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BCFF8B0-A2F4-4BBE-9279-774D5EDAE06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15599" y="6491891"/>
            <a:ext cx="1428750" cy="1428750"/>
          </a:xfrm>
          <a:prstGeom prst="rect">
            <a:avLst/>
          </a:prstGeom>
        </p:spPr>
      </p:pic>
      <p:sp>
        <p:nvSpPr>
          <p:cNvPr id="21" name="TextBox 93">
            <a:extLst>
              <a:ext uri="{FF2B5EF4-FFF2-40B4-BE49-F238E27FC236}">
                <a16:creationId xmlns:a16="http://schemas.microsoft.com/office/drawing/2014/main" id="{50CA5A6B-4F34-4D82-88D0-28BDE05EDD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9078" y="2349525"/>
            <a:ext cx="1176276" cy="36933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activities to p53 hotspots</a:t>
            </a:r>
          </a:p>
        </p:txBody>
      </p:sp>
    </p:spTree>
    <p:extLst>
      <p:ext uri="{BB962C8B-B14F-4D97-AF65-F5344CB8AC3E}">
        <p14:creationId xmlns:p14="http://schemas.microsoft.com/office/powerpoint/2010/main" val="4365948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AF93DDF1-C968-4159-8B0F-0567E6AB8F38}"/>
              </a:ext>
            </a:extLst>
          </p:cNvPr>
          <p:cNvSpPr/>
          <p:nvPr/>
        </p:nvSpPr>
        <p:spPr>
          <a:xfrm>
            <a:off x="1014027" y="4051141"/>
            <a:ext cx="118318" cy="1750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sz="800"/>
          </a:p>
        </p:txBody>
      </p:sp>
      <p:sp>
        <p:nvSpPr>
          <p:cNvPr id="16" name="TextBox 1">
            <a:extLst>
              <a:ext uri="{FF2B5EF4-FFF2-40B4-BE49-F238E27FC236}">
                <a16:creationId xmlns:a16="http://schemas.microsoft.com/office/drawing/2014/main" id="{BBE945A6-6624-43D7-B1A0-70E70D4307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150" y="438150"/>
            <a:ext cx="235032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tended Data Figure 6</a:t>
            </a:r>
          </a:p>
        </p:txBody>
      </p: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DA483884-0BA9-49D0-80AF-147ECA4D54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8580215"/>
              </p:ext>
            </p:extLst>
          </p:nvPr>
        </p:nvGraphicFramePr>
        <p:xfrm>
          <a:off x="1039813" y="6540500"/>
          <a:ext cx="4090987" cy="2371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9" name="Prism 7" r:id="rId3" imgW="5273467" imgH="3056987" progId="Prism7.Document">
                  <p:embed/>
                </p:oleObj>
              </mc:Choice>
              <mc:Fallback>
                <p:oleObj name="Prism 7" r:id="rId3" imgW="5273467" imgH="3056987" progId="Prism7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DA483884-0BA9-49D0-80AF-147ECA4D542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39813" y="6540500"/>
                        <a:ext cx="4090987" cy="2371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A835CE3B-6212-4970-BE15-CA33C7C869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1782641"/>
              </p:ext>
            </p:extLst>
          </p:nvPr>
        </p:nvGraphicFramePr>
        <p:xfrm>
          <a:off x="4215944" y="1356239"/>
          <a:ext cx="2542429" cy="3832113"/>
        </p:xfrm>
        <a:graphic>
          <a:graphicData uri="http://schemas.openxmlformats.org/drawingml/2006/table">
            <a:tbl>
              <a:tblPr/>
              <a:tblGrid>
                <a:gridCol w="707563">
                  <a:extLst>
                    <a:ext uri="{9D8B030D-6E8A-4147-A177-3AD203B41FA5}">
                      <a16:colId xmlns:a16="http://schemas.microsoft.com/office/drawing/2014/main" val="802849041"/>
                    </a:ext>
                  </a:extLst>
                </a:gridCol>
                <a:gridCol w="1259222">
                  <a:extLst>
                    <a:ext uri="{9D8B030D-6E8A-4147-A177-3AD203B41FA5}">
                      <a16:colId xmlns:a16="http://schemas.microsoft.com/office/drawing/2014/main" val="643594357"/>
                    </a:ext>
                  </a:extLst>
                </a:gridCol>
                <a:gridCol w="287822">
                  <a:extLst>
                    <a:ext uri="{9D8B030D-6E8A-4147-A177-3AD203B41FA5}">
                      <a16:colId xmlns:a16="http://schemas.microsoft.com/office/drawing/2014/main" val="3422645915"/>
                    </a:ext>
                  </a:extLst>
                </a:gridCol>
                <a:gridCol w="287822">
                  <a:extLst>
                    <a:ext uri="{9D8B030D-6E8A-4147-A177-3AD203B41FA5}">
                      <a16:colId xmlns:a16="http://schemas.microsoft.com/office/drawing/2014/main" val="3898183983"/>
                    </a:ext>
                  </a:extLst>
                </a:gridCol>
              </a:tblGrid>
              <a:tr h="89944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497" marR="4497" marT="44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497" marR="4497" marT="449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O</a:t>
                      </a:r>
                      <a:b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8147546"/>
                  </a:ext>
                </a:extLst>
              </a:tr>
              <a:tr h="89944"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497" marR="4497" marT="44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497" marR="4497" marT="4497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6275394"/>
                  </a:ext>
                </a:extLst>
              </a:tr>
              <a:tr h="94442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97" marR="4497" marT="4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97" marR="4497" marT="4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1633182"/>
                  </a:ext>
                </a:extLst>
              </a:tr>
              <a:tr h="94442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97" marR="4497" marT="449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97" marR="4497" marT="4497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ted</a:t>
                      </a:r>
                    </a:p>
                  </a:txBody>
                  <a:tcPr marL="4497" marR="4497" marT="44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imulated</a:t>
                      </a:r>
                    </a:p>
                  </a:txBody>
                  <a:tcPr marL="4497" marR="4497" marT="4497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2643289"/>
                  </a:ext>
                </a:extLst>
              </a:tr>
              <a:tr h="89944">
                <a:tc rowSpan="7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ospholipid Metabolism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oline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49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1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9293968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oline phosphate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1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1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3162132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cerophosphorylcholine (GPC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53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69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2643800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osphoethanolamine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49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4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1426563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idine-5'-diphosphoethanolamine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1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7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1425665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cerophosphoethanolamine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30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40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3443838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cerophosphoinositol*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36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53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9028682"/>
                  </a:ext>
                </a:extLst>
              </a:tr>
              <a:tr h="89944">
                <a:tc rowSpan="11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osphatidylcholine (PC)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myristoyl-2-palmitoyl-GPC (14:0/16:0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4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75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3437278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2-dipalmitoyl-GPC (16:0/16:0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2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55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0116817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palmitoyl-2-palmitoleoyl-GPC (16:0/16:1)*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8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61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2237550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palmitoyl-2-stearoyl-GPC (16:0/18:0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79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2.06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9057093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palmitoyl-2-oleoyl-GPC (16:0/18:1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9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8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3974523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palmitoyl-2-linoleoyl-GPC (16:0/18:2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44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3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9883446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palmitoyl-2-dihomo-linolenoyl-GPC (16:0/20:3n3 or 6)*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1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64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9850119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oleoyl-GPC (18:0/18:1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47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82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7619592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docosahexaenoyl-GPC (18:0/22:6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84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92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2938543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oleoyl-2-linoleoyl-GPC (18:1/18:2)*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37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64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2808778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2-dilinoleoyl-GPC (18:2/18:2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37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60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4766899"/>
                  </a:ext>
                </a:extLst>
              </a:tr>
              <a:tr h="89944">
                <a:tc rowSpan="8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palmitoyl-2-oleoyl-GPE (16:0/18:1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7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59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9854525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palmitoyl-2-linoleoyl-GPE (16:0/18:2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31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57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882858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palmitoyl-2-arachidonoyl-GPE (16:0/20:4)*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0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8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7788861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oleoyl-GPE (18:0/18:1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33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55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7410209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linoleoyl-GPE (18:0/18:2)*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33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60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5011110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arachidonoyl-GPE (18:0/20:4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2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69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3912206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docosahexaenoyl-GPE (18:0/22:6)*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5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2.06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6791761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oleoyl-2-linoleoyl-GPE (18:1/18:2)*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25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35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735808"/>
                  </a:ext>
                </a:extLst>
              </a:tr>
              <a:tr h="89944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oleoyl-GPS (18:0/18:1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25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59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8660250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linoleoyl-GPS (18:0/18:2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55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83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7193415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arachidonoyl-GPS (18:0/20:4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54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8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3670570"/>
                  </a:ext>
                </a:extLst>
              </a:tr>
              <a:tr h="8994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osphatidylinositol (PI)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linoleoyl-GPI (18:0/18:2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2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2.19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95316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-stearoyl-2-arachidonoyl-GPI (18:0/20:4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5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60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0734884"/>
                  </a:ext>
                </a:extLst>
              </a:tr>
              <a:tr h="94442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97" marR="4497" marT="449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97" marR="4497" marT="449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97" marR="4497" marT="449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497" marR="4497" marT="449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5440818"/>
                  </a:ext>
                </a:extLst>
              </a:tr>
              <a:tr h="89944">
                <a:tc rowSpan="6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rea cycle; Arginine and Proline Metabolism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ginine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70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82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4309196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nithine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3.90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3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8771966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ulline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56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6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2539627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line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7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2.17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3024747"/>
                  </a:ext>
                </a:extLst>
              </a:tr>
              <a:tr h="899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methylarginine (SDMA + ADMA)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1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4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0062068"/>
                  </a:ext>
                </a:extLst>
              </a:tr>
              <a:tr h="944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-4-hydroxyproline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48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5</a:t>
                      </a:r>
                    </a:p>
                  </a:txBody>
                  <a:tcPr marL="4497" marR="4497" marT="44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4619609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7F381476-E1FE-4B5E-A436-8E215BDEE4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4997116"/>
              </p:ext>
            </p:extLst>
          </p:nvPr>
        </p:nvGraphicFramePr>
        <p:xfrm>
          <a:off x="1014027" y="1340999"/>
          <a:ext cx="2639374" cy="3795657"/>
        </p:xfrm>
        <a:graphic>
          <a:graphicData uri="http://schemas.openxmlformats.org/drawingml/2006/table">
            <a:tbl>
              <a:tblPr/>
              <a:tblGrid>
                <a:gridCol w="734543">
                  <a:extLst>
                    <a:ext uri="{9D8B030D-6E8A-4147-A177-3AD203B41FA5}">
                      <a16:colId xmlns:a16="http://schemas.microsoft.com/office/drawing/2014/main" val="2756427640"/>
                    </a:ext>
                  </a:extLst>
                </a:gridCol>
                <a:gridCol w="1307237">
                  <a:extLst>
                    <a:ext uri="{9D8B030D-6E8A-4147-A177-3AD203B41FA5}">
                      <a16:colId xmlns:a16="http://schemas.microsoft.com/office/drawing/2014/main" val="1248528522"/>
                    </a:ext>
                  </a:extLst>
                </a:gridCol>
                <a:gridCol w="298797">
                  <a:extLst>
                    <a:ext uri="{9D8B030D-6E8A-4147-A177-3AD203B41FA5}">
                      <a16:colId xmlns:a16="http://schemas.microsoft.com/office/drawing/2014/main" val="3506775689"/>
                    </a:ext>
                  </a:extLst>
                </a:gridCol>
                <a:gridCol w="298797">
                  <a:extLst>
                    <a:ext uri="{9D8B030D-6E8A-4147-A177-3AD203B41FA5}">
                      <a16:colId xmlns:a16="http://schemas.microsoft.com/office/drawing/2014/main" val="2511000946"/>
                    </a:ext>
                  </a:extLst>
                </a:gridCol>
              </a:tblGrid>
              <a:tr h="93374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 gridSpan="2"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O</a:t>
                      </a:r>
                      <a:b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5877467"/>
                  </a:ext>
                </a:extLst>
              </a:tr>
              <a:tr h="93374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4953888"/>
                  </a:ext>
                </a:extLst>
              </a:tr>
              <a:tr h="9804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292721"/>
                  </a:ext>
                </a:extLst>
              </a:tr>
              <a:tr h="9804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ted</a:t>
                      </a:r>
                    </a:p>
                  </a:txBody>
                  <a:tcPr marL="4669" marR="4669" marT="46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imulated</a:t>
                      </a:r>
                    </a:p>
                  </a:txBody>
                  <a:tcPr marL="4669" marR="4669" marT="46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878325"/>
                  </a:ext>
                </a:extLst>
              </a:tr>
              <a:tr h="93374">
                <a:tc rowSpan="7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colysis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cos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4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473176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hydroxyacetone phosphate (DHAP)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6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2.14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5899541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-phosphoglycerat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47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48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595992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osphoenolpyruvate (PEP)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39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43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8880336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yruvat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67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83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7243404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actat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4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27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3532503"/>
                  </a:ext>
                </a:extLst>
              </a:tr>
              <a:tr h="980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cerat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9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7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9117016"/>
                  </a:ext>
                </a:extLst>
              </a:tr>
              <a:tr h="9804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700055"/>
                  </a:ext>
                </a:extLst>
              </a:tr>
              <a:tr h="93374">
                <a:tc rowSpan="5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A Cycle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at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59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29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3567172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onitate [cis or trans]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66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32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8255488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pha-ketoglutarat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7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4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8959014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umarat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2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64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8018687"/>
                  </a:ext>
                </a:extLst>
              </a:tr>
              <a:tr h="980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at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56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82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0634824"/>
                  </a:ext>
                </a:extLst>
              </a:tr>
              <a:tr h="9804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7585069"/>
                  </a:ext>
                </a:extLst>
              </a:tr>
              <a:tr h="93374">
                <a:tc rowSpan="5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ospholipid Metabolism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ol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49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1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4405062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cerophosphorylcholine (GPC)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53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69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9190040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osphoethanolam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49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4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6634936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cerophosphoethanolam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3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4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6838940"/>
                  </a:ext>
                </a:extLst>
              </a:tr>
              <a:tr h="980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cerophosphoinositol*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36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53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7245994"/>
                  </a:ext>
                </a:extLst>
              </a:tr>
              <a:tr h="9804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3471129"/>
                  </a:ext>
                </a:extLst>
              </a:tr>
              <a:tr h="93374">
                <a:tc rowSpan="4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rea cycle; Arginine and Proline Metabolism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gin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7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82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3660723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nith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3.9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3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484923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trull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56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6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2215194"/>
                  </a:ext>
                </a:extLst>
              </a:tr>
              <a:tr h="980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l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77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2.17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1079434"/>
                  </a:ext>
                </a:extLst>
              </a:tr>
              <a:tr h="98043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4734511"/>
                  </a:ext>
                </a:extLst>
              </a:tr>
              <a:tr h="93374">
                <a:tc rowSpan="5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tathione Metabolism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tathione, reduced (GSH)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2.9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3.24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0869294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tathione, oxidized (GSSG)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2.95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2.57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5762249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steine-glutathione disulfid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5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9059684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-oxoprol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4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35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7470646"/>
                  </a:ext>
                </a:extLst>
              </a:tr>
              <a:tr h="980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phthalmat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3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6387642"/>
                  </a:ext>
                </a:extLst>
              </a:tr>
              <a:tr h="98043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4669" marR="4669" marT="46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2168255"/>
                  </a:ext>
                </a:extLst>
              </a:tr>
              <a:tr h="93374">
                <a:tc rowSpan="5"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lyamine Metabolism</a:t>
                      </a:r>
                    </a:p>
                  </a:txBody>
                  <a:tcPr marL="54386" marR="54386" marT="27193" marB="27193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utresc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3.52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8.67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61306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ermid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4.92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5.76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7946930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N(1) + N(8))-acetylspermid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2.10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64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4084075"/>
                  </a:ext>
                </a:extLst>
              </a:tr>
              <a:tr h="933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permine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FFFF00"/>
                          </a:solidFill>
                          <a:effectLst/>
                          <a:latin typeface="Arial" panose="020B0604020202020204" pitchFamily="34" charset="0"/>
                        </a:rPr>
                        <a:t>1.96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6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577510"/>
                  </a:ext>
                </a:extLst>
              </a:tr>
              <a:tr h="980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-methylthioadenosine (MTA)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34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18</a:t>
                      </a:r>
                    </a:p>
                  </a:txBody>
                  <a:tcPr marL="4669" marR="4669" marT="466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8182400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DAB7474A-BB81-4C5C-B810-BB20EAF633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7364576"/>
              </p:ext>
            </p:extLst>
          </p:nvPr>
        </p:nvGraphicFramePr>
        <p:xfrm>
          <a:off x="1073186" y="5319223"/>
          <a:ext cx="2866354" cy="487269"/>
        </p:xfrm>
        <a:graphic>
          <a:graphicData uri="http://schemas.openxmlformats.org/drawingml/2006/table">
            <a:tbl>
              <a:tblPr/>
              <a:tblGrid>
                <a:gridCol w="461956">
                  <a:extLst>
                    <a:ext uri="{9D8B030D-6E8A-4147-A177-3AD203B41FA5}">
                      <a16:colId xmlns:a16="http://schemas.microsoft.com/office/drawing/2014/main" val="3271556574"/>
                    </a:ext>
                  </a:extLst>
                </a:gridCol>
                <a:gridCol w="2404398">
                  <a:extLst>
                    <a:ext uri="{9D8B030D-6E8A-4147-A177-3AD203B41FA5}">
                      <a16:colId xmlns:a16="http://schemas.microsoft.com/office/drawing/2014/main" val="1299031405"/>
                    </a:ext>
                  </a:extLst>
                </a:gridCol>
              </a:tblGrid>
              <a:tr h="1040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E7E200"/>
                          </a:solidFill>
                          <a:effectLst/>
                          <a:latin typeface="Arial" panose="020B0604020202020204" pitchFamily="34" charset="0"/>
                        </a:rPr>
                        <a:t>0.55</a:t>
                      </a:r>
                    </a:p>
                  </a:txBody>
                  <a:tcPr marL="3586" marR="3586" marT="358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een: indicates significant difference (p≤0.05) between the groups shown, metabolite ratio of &lt; 1.00</a:t>
                      </a:r>
                    </a:p>
                  </a:txBody>
                  <a:tcPr marL="3586" marR="3586" marT="35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1520886"/>
                  </a:ext>
                </a:extLst>
              </a:tr>
              <a:tr h="1050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0.76</a:t>
                      </a:r>
                    </a:p>
                  </a:txBody>
                  <a:tcPr marL="3586" marR="3586" marT="358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0EE9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ht Green: narrowly missed statistical cutoff for significance 0.05&lt;p&lt;0.10, metabolite ratio of &lt; 1.00</a:t>
                      </a:r>
                    </a:p>
                  </a:txBody>
                  <a:tcPr marL="3586" marR="3586" marT="35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7555252"/>
                  </a:ext>
                </a:extLst>
              </a:tr>
              <a:tr h="10097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E7E200"/>
                          </a:solidFill>
                          <a:effectLst/>
                          <a:latin typeface="Arial" panose="020B0604020202020204" pitchFamily="34" charset="0"/>
                        </a:rPr>
                        <a:t>1.71</a:t>
                      </a:r>
                    </a:p>
                  </a:txBody>
                  <a:tcPr marL="3586" marR="3586" marT="358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d: indicates significant difference (p≤0.05) between the groups shown; metabolite ratio of ≥ 1.00</a:t>
                      </a:r>
                    </a:p>
                  </a:txBody>
                  <a:tcPr marL="3586" marR="3586" marT="35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4670660"/>
                  </a:ext>
                </a:extLst>
              </a:tr>
              <a:tr h="870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 dirty="0">
                          <a:solidFill>
                            <a:srgbClr val="000080"/>
                          </a:solidFill>
                          <a:effectLst/>
                          <a:latin typeface="Arial" panose="020B0604020202020204" pitchFamily="34" charset="0"/>
                        </a:rPr>
                        <a:t>1.32</a:t>
                      </a:r>
                    </a:p>
                  </a:txBody>
                  <a:tcPr marL="3586" marR="3586" marT="358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C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ht Red: narrowly missed statistical cutoff for significance 0.05&lt;p&lt;0.10, metabolite ratio of ≥ 1.00</a:t>
                      </a:r>
                    </a:p>
                  </a:txBody>
                  <a:tcPr marL="3586" marR="3586" marT="35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5185299"/>
                  </a:ext>
                </a:extLst>
              </a:tr>
              <a:tr h="901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0</a:t>
                      </a:r>
                    </a:p>
                  </a:txBody>
                  <a:tcPr marL="3586" marR="3586" marT="358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-colored text and cell: mean values are not significantly different for that comparison</a:t>
                      </a:r>
                    </a:p>
                  </a:txBody>
                  <a:tcPr marL="3586" marR="3586" marT="35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9229361"/>
                  </a:ext>
                </a:extLst>
              </a:tr>
            </a:tbl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E5EA31BF-C0C0-4182-85F5-DCB4645421EA}"/>
              </a:ext>
            </a:extLst>
          </p:cNvPr>
          <p:cNvSpPr txBox="1"/>
          <p:nvPr/>
        </p:nvSpPr>
        <p:spPr>
          <a:xfrm>
            <a:off x="701121" y="1217739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AFE2A24-8AEC-449F-B370-DEE08D4EF173}"/>
              </a:ext>
            </a:extLst>
          </p:cNvPr>
          <p:cNvSpPr txBox="1"/>
          <p:nvPr/>
        </p:nvSpPr>
        <p:spPr>
          <a:xfrm>
            <a:off x="876300" y="6383293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4224394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050" dirty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7100C7699C73A498CB057F667D9CD99" ma:contentTypeVersion="2" ma:contentTypeDescription="Create a new document." ma:contentTypeScope="" ma:versionID="d27b0a1a194154917423e43d47b340ec">
  <xsd:schema xmlns:xsd="http://www.w3.org/2001/XMLSchema" xmlns:xs="http://www.w3.org/2001/XMLSchema" xmlns:p="http://schemas.microsoft.com/office/2006/metadata/properties" xmlns:ns3="0b516ab0-04e4-4c88-99cd-523706b96b1a" targetNamespace="http://schemas.microsoft.com/office/2006/metadata/properties" ma:root="true" ma:fieldsID="267dcfd05327c8ceb27eb7b29564e896" ns3:_="">
    <xsd:import namespace="0b516ab0-04e4-4c88-99cd-523706b96b1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516ab0-04e4-4c88-99cd-523706b96b1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A1F8F76-3B26-47B4-BC80-A2E9D530D0A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86C16E4-8DAE-4080-A955-0A1C13A1EC56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950B5EC0-8703-429D-909D-A7531D4AA19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516ab0-04e4-4c88-99cd-523706b96b1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4025</TotalTime>
  <Words>713</Words>
  <Application>Microsoft Office PowerPoint</Application>
  <PresentationFormat>Custom</PresentationFormat>
  <Paragraphs>326</Paragraphs>
  <Slides>7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lmer, Doug (NIH/NCI) [E]</dc:creator>
  <cp:lastModifiedBy>Palmer, Doug (NIH/NCI) [E]</cp:lastModifiedBy>
  <cp:revision>849</cp:revision>
  <cp:lastPrinted>2020-09-15T19:13:19Z</cp:lastPrinted>
  <dcterms:created xsi:type="dcterms:W3CDTF">2017-02-07T21:30:49Z</dcterms:created>
  <dcterms:modified xsi:type="dcterms:W3CDTF">2020-09-24T19:12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7100C7699C73A498CB057F667D9CD99</vt:lpwstr>
  </property>
</Properties>
</file>